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360045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CBB4B7-C9C0-4CB5-84B1-C2B3102F068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59148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71600" y="2152440"/>
            <a:ext cx="59148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E55E61-0A58-4C30-8653-F9C3BD1E62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244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71600" y="215244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2440" y="215244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6FC051-0D83-4ADE-AB40-4F7592CAF85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71760" y="95868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71560" y="95868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71600" y="215244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71760" y="215244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71560" y="2152440"/>
            <a:ext cx="19044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35830A-44AF-4095-8DD7-E13500E1F30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71600" y="958680"/>
            <a:ext cx="5914800" cy="2284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524"/>
              </a:spcBef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DCA69-ABE8-40C1-B69B-98507319C1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591480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73F878-9131-4AB3-AD90-7B54BFBC8F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288612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2440" y="958680"/>
            <a:ext cx="288612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28CEF1-60D4-4107-8687-1A90B64E14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0BF74D-7AE5-493E-A54B-1F8BDFC0200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71600" y="191880"/>
            <a:ext cx="5914800" cy="3223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524"/>
              </a:spcBef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7E2C3-9FD8-4C58-962F-566FD230227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2440" y="958680"/>
            <a:ext cx="288612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71600" y="215244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FB6400-7B85-4F05-BD9A-2EEE95E6778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288612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244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2440" y="215244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8287A2-2717-4F67-BE4D-8725E36BDD8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7160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2440" y="958680"/>
            <a:ext cx="288612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71600" y="2152440"/>
            <a:ext cx="5914800" cy="1089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524"/>
              </a:spcBef>
              <a:buNone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45C445-CB46-47E4-8864-DFC9F23B866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71600" y="191880"/>
            <a:ext cx="5914800" cy="695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23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23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71600" y="958680"/>
            <a:ext cx="5914800" cy="2284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11916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1" marL="35892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2" marL="60012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3" marL="83988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4" marL="107964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5" marL="107964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lvl="6" marL="1079640" indent="-119160">
              <a:lnSpc>
                <a:spcPct val="90000"/>
              </a:lnSpc>
              <a:spcBef>
                <a:spcPts val="524"/>
              </a:spcBef>
              <a:buClr>
                <a:srgbClr val="000000"/>
              </a:buClr>
              <a:buFont typeface="Arial"/>
              <a:buChar char="•"/>
              <a:tabLst>
                <a:tab algn="l" pos="479520"/>
                <a:tab algn="l" pos="958680"/>
                <a:tab algn="l" pos="1438200"/>
                <a:tab algn="l" pos="1917720"/>
                <a:tab algn="l" pos="2397240"/>
                <a:tab algn="l" pos="2876400"/>
                <a:tab algn="l" pos="3355920"/>
                <a:tab algn="l" pos="3835440"/>
                <a:tab algn="l" pos="4314960"/>
                <a:tab algn="l" pos="4794120"/>
                <a:tab algn="l" pos="5273640"/>
                <a:tab algn="l" pos="5753160"/>
                <a:tab algn="l" pos="6232680"/>
                <a:tab algn="l" pos="6711840"/>
                <a:tab algn="l" pos="7191360"/>
                <a:tab algn="l" pos="7670880"/>
                <a:tab algn="l" pos="8150400"/>
                <a:tab algn="l" pos="8629560"/>
                <a:tab algn="l" pos="9109080"/>
                <a:tab algn="l" pos="9588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71600" y="3336840"/>
            <a:ext cx="1542960" cy="192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6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zh-CN" sz="600" spc="-1" strike="noStrike">
                <a:solidFill>
                  <a:srgbClr val="898989"/>
                </a:solidFill>
                <a:latin typeface="Calibri"/>
                <a:ea typeface="等线"/>
              </a:rPr>
              <a:t>&lt;date/time&gt;</a:t>
            </a:r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271600" y="3336840"/>
            <a:ext cx="2314800" cy="192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843440" y="3336840"/>
            <a:ext cx="1542960" cy="192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zh-CN" sz="600" spc="-1" strike="noStrike">
                <a:solidFill>
                  <a:srgbClr val="898989"/>
                </a:solidFill>
                <a:latin typeface="Calibri"/>
                <a:ea typeface="等线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CAF57942-6E77-445E-851C-B85D7406147F}" type="slidenum">
              <a:rPr b="0" lang="zh-CN" sz="600" spc="-1" strike="noStrike">
                <a:solidFill>
                  <a:srgbClr val="898989"/>
                </a:solidFill>
                <a:latin typeface="Calibri"/>
                <a:ea typeface="等线"/>
              </a:rPr>
              <a:t>&lt;number&gt;</a:t>
            </a:fld>
            <a:endParaRPr b="0" lang="en-US" sz="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1"/>
          <p:cNvGrpSpPr/>
          <p:nvPr/>
        </p:nvGrpSpPr>
        <p:grpSpPr>
          <a:xfrm>
            <a:off x="419040" y="390600"/>
            <a:ext cx="5765400" cy="2499120"/>
            <a:chOff x="419040" y="390600"/>
            <a:chExt cx="5765400" cy="2499120"/>
          </a:xfrm>
        </p:grpSpPr>
        <p:pic>
          <p:nvPicPr>
            <p:cNvPr id="42" name="图片 3" descr=""/>
            <p:cNvPicPr/>
            <p:nvPr/>
          </p:nvPicPr>
          <p:blipFill>
            <a:blip r:embed="rId1"/>
            <a:stretch/>
          </p:blipFill>
          <p:spPr>
            <a:xfrm>
              <a:off x="940680" y="604800"/>
              <a:ext cx="2058480" cy="20638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图片 4" descr=""/>
            <p:cNvPicPr/>
            <p:nvPr/>
          </p:nvPicPr>
          <p:blipFill>
            <a:blip r:embed="rId2"/>
            <a:stretch/>
          </p:blipFill>
          <p:spPr>
            <a:xfrm>
              <a:off x="3804120" y="604800"/>
              <a:ext cx="2039400" cy="20624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文本框 5"/>
            <p:cNvSpPr/>
            <p:nvPr/>
          </p:nvSpPr>
          <p:spPr>
            <a:xfrm>
              <a:off x="540360" y="247500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文本框 6"/>
            <p:cNvSpPr/>
            <p:nvPr/>
          </p:nvSpPr>
          <p:spPr>
            <a:xfrm>
              <a:off x="540360" y="182736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文本框 7"/>
            <p:cNvSpPr/>
            <p:nvPr/>
          </p:nvSpPr>
          <p:spPr>
            <a:xfrm>
              <a:off x="540360" y="117792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文本框 8"/>
            <p:cNvSpPr/>
            <p:nvPr/>
          </p:nvSpPr>
          <p:spPr>
            <a:xfrm>
              <a:off x="540360" y="52848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1.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文本框 9"/>
            <p:cNvSpPr/>
            <p:nvPr/>
          </p:nvSpPr>
          <p:spPr>
            <a:xfrm>
              <a:off x="1195920" y="2633760"/>
              <a:ext cx="579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文本框 10"/>
            <p:cNvSpPr/>
            <p:nvPr/>
          </p:nvSpPr>
          <p:spPr>
            <a:xfrm>
              <a:off x="2135880" y="2633760"/>
              <a:ext cx="704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Matrin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文本框 11"/>
            <p:cNvSpPr/>
            <p:nvPr/>
          </p:nvSpPr>
          <p:spPr>
            <a:xfrm>
              <a:off x="3386520" y="247500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文本框 12"/>
            <p:cNvSpPr/>
            <p:nvPr/>
          </p:nvSpPr>
          <p:spPr>
            <a:xfrm>
              <a:off x="3386520" y="182736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0.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文本框 13"/>
            <p:cNvSpPr/>
            <p:nvPr/>
          </p:nvSpPr>
          <p:spPr>
            <a:xfrm>
              <a:off x="3386520" y="117792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1.0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文本框 14"/>
            <p:cNvSpPr/>
            <p:nvPr/>
          </p:nvSpPr>
          <p:spPr>
            <a:xfrm>
              <a:off x="3386520" y="528480"/>
              <a:ext cx="523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1.5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文本框 15"/>
            <p:cNvSpPr/>
            <p:nvPr/>
          </p:nvSpPr>
          <p:spPr>
            <a:xfrm>
              <a:off x="4061160" y="2643480"/>
              <a:ext cx="580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DMSO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文本框 16"/>
            <p:cNvSpPr/>
            <p:nvPr/>
          </p:nvSpPr>
          <p:spPr>
            <a:xfrm>
              <a:off x="4992840" y="2643480"/>
              <a:ext cx="738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Matrine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56" name="组合 23"/>
            <p:cNvGrpSpPr/>
            <p:nvPr/>
          </p:nvGrpSpPr>
          <p:grpSpPr>
            <a:xfrm>
              <a:off x="2342160" y="763560"/>
              <a:ext cx="963360" cy="372600"/>
              <a:chOff x="2342160" y="763560"/>
              <a:chExt cx="963360" cy="372600"/>
            </a:xfrm>
          </p:grpSpPr>
          <p:sp>
            <p:nvSpPr>
              <p:cNvPr id="57" name="矩形 17"/>
              <p:cNvSpPr/>
              <p:nvPr/>
            </p:nvSpPr>
            <p:spPr>
              <a:xfrm>
                <a:off x="2342160" y="847800"/>
                <a:ext cx="158400" cy="75600"/>
              </a:xfrm>
              <a:prstGeom prst="rect">
                <a:avLst/>
              </a:prstGeom>
              <a:solidFill>
                <a:srgbClr val="a0a0a4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矩形 18"/>
              <p:cNvSpPr/>
              <p:nvPr/>
            </p:nvSpPr>
            <p:spPr>
              <a:xfrm>
                <a:off x="2342160" y="974880"/>
                <a:ext cx="158400" cy="7560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文本框 19"/>
              <p:cNvSpPr/>
              <p:nvPr/>
            </p:nvSpPr>
            <p:spPr>
              <a:xfrm>
                <a:off x="2487240" y="763560"/>
                <a:ext cx="818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微软雅黑"/>
                  </a:rPr>
                  <a:t>Untreated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文本框 22"/>
              <p:cNvSpPr/>
              <p:nvPr/>
            </p:nvSpPr>
            <p:spPr>
              <a:xfrm>
                <a:off x="2487240" y="889920"/>
                <a:ext cx="8182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微软雅黑"/>
                  </a:rPr>
                  <a:t>3-MA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grpSp>
          <p:nvGrpSpPr>
            <p:cNvPr id="61" name="组合 24"/>
            <p:cNvGrpSpPr/>
            <p:nvPr/>
          </p:nvGrpSpPr>
          <p:grpSpPr>
            <a:xfrm>
              <a:off x="5221440" y="763560"/>
              <a:ext cx="963000" cy="372600"/>
              <a:chOff x="5221440" y="763560"/>
              <a:chExt cx="963000" cy="372600"/>
            </a:xfrm>
          </p:grpSpPr>
          <p:sp>
            <p:nvSpPr>
              <p:cNvPr id="62" name="矩形 25"/>
              <p:cNvSpPr/>
              <p:nvPr/>
            </p:nvSpPr>
            <p:spPr>
              <a:xfrm>
                <a:off x="5221440" y="847800"/>
                <a:ext cx="158400" cy="75600"/>
              </a:xfrm>
              <a:prstGeom prst="rect">
                <a:avLst/>
              </a:prstGeom>
              <a:solidFill>
                <a:srgbClr val="a0a0a4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矩形 26"/>
              <p:cNvSpPr/>
              <p:nvPr/>
            </p:nvSpPr>
            <p:spPr>
              <a:xfrm>
                <a:off x="5221440" y="974880"/>
                <a:ext cx="158400" cy="75600"/>
              </a:xfrm>
              <a:prstGeom prst="rect">
                <a:avLst/>
              </a:prstGeom>
              <a:solidFill>
                <a:srgbClr val="000000"/>
              </a:solidFill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ctr">
                <a:noAutofit/>
              </a:bodyPr>
              <a:p>
                <a:pPr algn="ctr"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文本框 27"/>
              <p:cNvSpPr/>
              <p:nvPr/>
            </p:nvSpPr>
            <p:spPr>
              <a:xfrm>
                <a:off x="5365800" y="763560"/>
                <a:ext cx="818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微软雅黑"/>
                  </a:rPr>
                  <a:t>Untreated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文本框 28"/>
              <p:cNvSpPr/>
              <p:nvPr/>
            </p:nvSpPr>
            <p:spPr>
              <a:xfrm>
                <a:off x="5365800" y="889920"/>
                <a:ext cx="818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Arial"/>
                    <a:ea typeface="微软雅黑"/>
                  </a:rPr>
                  <a:t>3-MA</a:t>
                </a:r>
                <a:endParaRPr b="0" lang="en-US" sz="10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6" name="文本框 34"/>
            <p:cNvSpPr/>
            <p:nvPr/>
          </p:nvSpPr>
          <p:spPr>
            <a:xfrm rot="10800000">
              <a:off x="419040" y="593280"/>
              <a:ext cx="332640" cy="208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ell viability( 100% of control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文本框 34"/>
            <p:cNvSpPr/>
            <p:nvPr/>
          </p:nvSpPr>
          <p:spPr>
            <a:xfrm rot="10800000">
              <a:off x="3269520" y="591840"/>
              <a:ext cx="332640" cy="2086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宋体"/>
                </a:rPr>
                <a:t>Cell viability( 100% of control)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文本框 31"/>
            <p:cNvSpPr/>
            <p:nvPr/>
          </p:nvSpPr>
          <p:spPr>
            <a:xfrm>
              <a:off x="1513440" y="390600"/>
              <a:ext cx="89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SK-N-A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文本框 32"/>
            <p:cNvSpPr/>
            <p:nvPr/>
          </p:nvSpPr>
          <p:spPr>
            <a:xfrm>
              <a:off x="4374000" y="390600"/>
              <a:ext cx="89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SK-N-DZ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文本框 1"/>
            <p:cNvSpPr/>
            <p:nvPr/>
          </p:nvSpPr>
          <p:spPr>
            <a:xfrm>
              <a:off x="2345400" y="1203480"/>
              <a:ext cx="287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文本框 2"/>
            <p:cNvSpPr/>
            <p:nvPr/>
          </p:nvSpPr>
          <p:spPr>
            <a:xfrm>
              <a:off x="5175360" y="1203480"/>
              <a:ext cx="3362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  <a:ea typeface="微软雅黑"/>
                </a:rPr>
                <a:t>***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19T02:08:00Z</dcterms:created>
  <dc:creator>Administrator</dc:creator>
  <dc:description/>
  <dc:language>en-US</dc:language>
  <cp:lastModifiedBy>He</cp:lastModifiedBy>
  <dcterms:modified xsi:type="dcterms:W3CDTF">2022-05-30T09:00:06Z</dcterms:modified>
  <cp:revision>209</cp:revision>
  <dc:subject/>
  <dc:title>空白演示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24FF29DFF7A49598CFB39277553D729</vt:lpwstr>
  </property>
  <property fmtid="{D5CDD505-2E9C-101B-9397-08002B2CF9AE}" pid="3" name="KSOProductBuildVer">
    <vt:lpwstr>2052-11.1.0.10578</vt:lpwstr>
  </property>
</Properties>
</file>